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59"/>
  </p:normalViewPr>
  <p:slideViewPr>
    <p:cSldViewPr snapToGrid="0" snapToObjects="1">
      <p:cViewPr varScale="1">
        <p:scale>
          <a:sx n="110" d="100"/>
          <a:sy n="110" d="100"/>
        </p:scale>
        <p:origin x="63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8391EF5D-067D-4444-A9E6-8EC08A80BD3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Υπότιτλος 2">
            <a:extLst>
              <a:ext uri="{FF2B5EF4-FFF2-40B4-BE49-F238E27FC236}">
                <a16:creationId xmlns:a16="http://schemas.microsoft.com/office/drawing/2014/main" id="{8EC85CE1-EE48-2F4B-A460-9E8FB9ADD6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6FF565DB-2F64-1548-A044-E3A62DB79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D54A75-1C88-3E4F-AA21-625490C3EAF7}" type="datetimeFigureOut">
              <a:rPr lang="el-GR" smtClean="0"/>
              <a:t>9/4/21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A6E3A584-6632-864A-B30B-08AFA11AD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6A12EA3F-36F9-394C-BF11-07A9E4455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00D4F-DB1F-384D-BCE6-5A5719FEE73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123826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950AE9C1-D060-AD45-B01E-B2702FAE15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23874C7B-2024-C940-890B-AF93DF7EB8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F8B6DCAB-837B-6A46-B15E-F0AFF29814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D54A75-1C88-3E4F-AA21-625490C3EAF7}" type="datetimeFigureOut">
              <a:rPr lang="el-GR" smtClean="0"/>
              <a:t>9/4/21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EB84840F-FB01-D548-99F6-3C4898166A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90A18F9C-EE82-8D41-B835-B4DDEF2BF3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00D4F-DB1F-384D-BCE6-5A5719FEE73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253145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Κατακόρυφος τίτλος 1">
            <a:extLst>
              <a:ext uri="{FF2B5EF4-FFF2-40B4-BE49-F238E27FC236}">
                <a16:creationId xmlns:a16="http://schemas.microsoft.com/office/drawing/2014/main" id="{17246FCB-CC94-384C-AFB7-C2C1930392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44ADE73A-5446-474C-BA0A-D4473B9139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064C63F5-02B0-554B-95A1-8DA865E93B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D54A75-1C88-3E4F-AA21-625490C3EAF7}" type="datetimeFigureOut">
              <a:rPr lang="el-GR" smtClean="0"/>
              <a:t>9/4/21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45CC780A-82DA-4040-B48C-E4D7A2B3B0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01D848EF-FAD0-BA40-840D-A3B3940B6F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00D4F-DB1F-384D-BCE6-5A5719FEE73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271480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18224D36-402A-9744-9232-EC1D3ECDA4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2782566E-02F9-424F-BA3D-EA95A0AE855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EC0FA9F2-69F1-5648-95D6-4A849E484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D54A75-1C88-3E4F-AA21-625490C3EAF7}" type="datetimeFigureOut">
              <a:rPr lang="el-GR" smtClean="0"/>
              <a:t>9/4/21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35F9A620-8DA1-6A4F-9C11-299E1642B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F05F0898-5389-FC42-A975-7987001F6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00D4F-DB1F-384D-BCE6-5A5719FEE73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58691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0E5775FC-A1C7-094E-9715-0B755CA24C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4299D9EF-253D-114B-9B94-7E6D3BDBF4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F2E0102A-62EB-E341-8402-EEB1795ED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D54A75-1C88-3E4F-AA21-625490C3EAF7}" type="datetimeFigureOut">
              <a:rPr lang="el-GR" smtClean="0"/>
              <a:t>9/4/21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75ADD25F-FDD3-8740-AFC8-7A7557C9A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477B9E6C-7FCD-DE4D-A9FA-246500CCB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00D4F-DB1F-384D-BCE6-5A5719FEE73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559963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502B01EB-13DA-8C4B-9FE1-70E2F5C9B6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1940F8AC-BBCC-E645-8A77-D2A25D7A3A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6C681D53-8327-F64B-82C5-BB92BE2A94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A044952E-0AED-EA42-A7F6-EE13BBC04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D54A75-1C88-3E4F-AA21-625490C3EAF7}" type="datetimeFigureOut">
              <a:rPr lang="el-GR" smtClean="0"/>
              <a:t>9/4/21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210D3C4F-78E7-BA41-864C-6C2469749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0ADEAC7F-F4F9-3248-9A8B-513D9534A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00D4F-DB1F-384D-BCE6-5A5719FEE73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185538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A41CA2A7-0381-F64B-B052-1EA866CD56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DE3E5305-8126-EA40-A3EA-1A89DCAE1F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25534A80-8903-714D-9B98-0D9A57A0FA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5" name="Θέση κειμένου 4">
            <a:extLst>
              <a:ext uri="{FF2B5EF4-FFF2-40B4-BE49-F238E27FC236}">
                <a16:creationId xmlns:a16="http://schemas.microsoft.com/office/drawing/2014/main" id="{B5AC37B6-4C96-784F-AD57-C03ACD08B1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Θέση περιεχομένου 5">
            <a:extLst>
              <a:ext uri="{FF2B5EF4-FFF2-40B4-BE49-F238E27FC236}">
                <a16:creationId xmlns:a16="http://schemas.microsoft.com/office/drawing/2014/main" id="{08C6B9B5-B2B5-C040-AD30-298FB1608D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7" name="Θέση ημερομηνίας 6">
            <a:extLst>
              <a:ext uri="{FF2B5EF4-FFF2-40B4-BE49-F238E27FC236}">
                <a16:creationId xmlns:a16="http://schemas.microsoft.com/office/drawing/2014/main" id="{37CEBC31-29A9-394B-B05E-A8BB1E4045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D54A75-1C88-3E4F-AA21-625490C3EAF7}" type="datetimeFigureOut">
              <a:rPr lang="el-GR" smtClean="0"/>
              <a:t>9/4/21</a:t>
            </a:fld>
            <a:endParaRPr lang="el-GR"/>
          </a:p>
        </p:txBody>
      </p:sp>
      <p:sp>
        <p:nvSpPr>
          <p:cNvPr id="8" name="Θέση υποσέλιδου 7">
            <a:extLst>
              <a:ext uri="{FF2B5EF4-FFF2-40B4-BE49-F238E27FC236}">
                <a16:creationId xmlns:a16="http://schemas.microsoft.com/office/drawing/2014/main" id="{A1654731-18B9-5F45-B9E0-1CC7AF552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Θέση αριθμού διαφάνειας 8">
            <a:extLst>
              <a:ext uri="{FF2B5EF4-FFF2-40B4-BE49-F238E27FC236}">
                <a16:creationId xmlns:a16="http://schemas.microsoft.com/office/drawing/2014/main" id="{64EA7A95-188C-014A-AC23-2162B9697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00D4F-DB1F-384D-BCE6-5A5719FEE73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8759415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9FE8DE7E-B2F2-4C47-BB71-8D74FD6C1A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ημερομηνίας 2">
            <a:extLst>
              <a:ext uri="{FF2B5EF4-FFF2-40B4-BE49-F238E27FC236}">
                <a16:creationId xmlns:a16="http://schemas.microsoft.com/office/drawing/2014/main" id="{F5E8F30A-6206-D447-8BF5-2A84C39AED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D54A75-1C88-3E4F-AA21-625490C3EAF7}" type="datetimeFigureOut">
              <a:rPr lang="el-GR" smtClean="0"/>
              <a:t>9/4/21</a:t>
            </a:fld>
            <a:endParaRPr lang="el-GR"/>
          </a:p>
        </p:txBody>
      </p:sp>
      <p:sp>
        <p:nvSpPr>
          <p:cNvPr id="4" name="Θέση υποσέλιδου 3">
            <a:extLst>
              <a:ext uri="{FF2B5EF4-FFF2-40B4-BE49-F238E27FC236}">
                <a16:creationId xmlns:a16="http://schemas.microsoft.com/office/drawing/2014/main" id="{9829B1A3-69C4-E742-A71E-2E3C85BCD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Θέση αριθμού διαφάνειας 4">
            <a:extLst>
              <a:ext uri="{FF2B5EF4-FFF2-40B4-BE49-F238E27FC236}">
                <a16:creationId xmlns:a16="http://schemas.microsoft.com/office/drawing/2014/main" id="{BD492347-4DF1-B74C-9EAF-AC077A0C75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00D4F-DB1F-384D-BCE6-5A5719FEE73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11444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ημερομηνίας 1">
            <a:extLst>
              <a:ext uri="{FF2B5EF4-FFF2-40B4-BE49-F238E27FC236}">
                <a16:creationId xmlns:a16="http://schemas.microsoft.com/office/drawing/2014/main" id="{5182D149-A4E5-8642-8018-BA0C89396E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D54A75-1C88-3E4F-AA21-625490C3EAF7}" type="datetimeFigureOut">
              <a:rPr lang="el-GR" smtClean="0"/>
              <a:t>9/4/21</a:t>
            </a:fld>
            <a:endParaRPr lang="el-GR"/>
          </a:p>
        </p:txBody>
      </p:sp>
      <p:sp>
        <p:nvSpPr>
          <p:cNvPr id="3" name="Θέση υποσέλιδου 2">
            <a:extLst>
              <a:ext uri="{FF2B5EF4-FFF2-40B4-BE49-F238E27FC236}">
                <a16:creationId xmlns:a16="http://schemas.microsoft.com/office/drawing/2014/main" id="{B68422E3-AE3C-C549-A1E1-B72849B93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Θέση αριθμού διαφάνειας 3">
            <a:extLst>
              <a:ext uri="{FF2B5EF4-FFF2-40B4-BE49-F238E27FC236}">
                <a16:creationId xmlns:a16="http://schemas.microsoft.com/office/drawing/2014/main" id="{34A5EB72-B32B-3A4F-8D2F-056A16D66A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00D4F-DB1F-384D-BCE6-5A5719FEE73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4409009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4914E3FB-BA54-2746-ACF7-9095DF5D8B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F12E97E8-FE1B-E741-A5C5-F2ECE49F10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599CBA97-EEA7-DA47-881D-B796E8BA18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3D904489-89FF-6744-8273-CBAAB1865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D54A75-1C88-3E4F-AA21-625490C3EAF7}" type="datetimeFigureOut">
              <a:rPr lang="el-GR" smtClean="0"/>
              <a:t>9/4/21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DBA2D09F-0534-0D49-BD31-2A7A1B11CF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4EC649CF-1835-A644-97EE-696D1A215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00D4F-DB1F-384D-BCE6-5A5719FEE73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467480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AB444115-DC3B-1045-BB24-8C444E7D31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εικόνας 2">
            <a:extLst>
              <a:ext uri="{FF2B5EF4-FFF2-40B4-BE49-F238E27FC236}">
                <a16:creationId xmlns:a16="http://schemas.microsoft.com/office/drawing/2014/main" id="{2697604C-3B2D-394B-A06D-ADBD0E181C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97E15AAF-672A-D044-B4CE-4171C41C7E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00565E46-566D-CB4A-92D5-BF2171FF0E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D54A75-1C88-3E4F-AA21-625490C3EAF7}" type="datetimeFigureOut">
              <a:rPr lang="el-GR" smtClean="0"/>
              <a:t>9/4/21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ABF791C0-AFFC-E942-B66F-3DA4EB0F9D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A6374535-0839-7343-9042-742170BA55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00D4F-DB1F-384D-BCE6-5A5719FEE73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361079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τίτλου 1">
            <a:extLst>
              <a:ext uri="{FF2B5EF4-FFF2-40B4-BE49-F238E27FC236}">
                <a16:creationId xmlns:a16="http://schemas.microsoft.com/office/drawing/2014/main" id="{BCEFC0A8-F0E5-FF4B-9334-3AE43FA3A3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C589329F-8336-5240-B8E9-044BF92973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2FF329A3-BC93-4C4E-A9D5-4CBE5CC3B3F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D54A75-1C88-3E4F-AA21-625490C3EAF7}" type="datetimeFigureOut">
              <a:rPr lang="el-GR" smtClean="0"/>
              <a:t>9/4/21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148B1568-4107-AD47-B3A6-191A71C568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2F7784AB-79EC-5044-9595-EA4DBA2218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600D4F-DB1F-384D-BCE6-5A5719FEE73A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91404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Εικόνα 4">
            <a:extLst>
              <a:ext uri="{FF2B5EF4-FFF2-40B4-BE49-F238E27FC236}">
                <a16:creationId xmlns:a16="http://schemas.microsoft.com/office/drawing/2014/main" id="{94684AA8-8FDC-3140-A277-592417D3E0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2050" y="139700"/>
            <a:ext cx="9867900" cy="6578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99999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AED22C1-0728-6A4E-BA38-327A66064F9C}"/>
              </a:ext>
            </a:extLst>
          </p:cNvPr>
          <p:cNvSpPr txBox="1"/>
          <p:nvPr/>
        </p:nvSpPr>
        <p:spPr>
          <a:xfrm>
            <a:off x="1314202" y="960581"/>
            <a:ext cx="9376229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PFGE of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ureus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DNA digestion with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a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s 1,30: molecular weight marker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ureus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TC 8325; Line 8: 8403, PFGE Type 1, ST121; Line 9: 8416, PFGE Type 1, ST121; Line 10: 8490, PFGE Type 2, ST1; Line 11: 8507, PFGE Type 1, ST121; Line 12: 8510, PFGE Type 1, ST121; Line 14: 6137, PFGE Type 1, ST121; Line 15: 7685, PFGE Type 1, ST121; Line 16: 7803, PFGE Type 1, ST121; Line 17: 51168, PFGE Type 1, ST121; Line 18: 7837, PFGE Type 1, ST121; Line 20: 6766, PFGE Type 1, ST121; Line 21: 6939, PFGE Type 1, ST121; Line 22: 7484, PFGE Type 1, ST121; Line 23: 7411, PFGE Type 1, ST121; Line 24: 8161, PFGE Type 1, ST121; Line 29: 7993, PFGE Type 4, ST21; Lines 2-7,13,19,25,26: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ureus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olates PFGE Type 1, ST121, not included in </a:t>
            </a:r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the dendrogram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Lines 27,28: Mupirocin-susceptible isolates, PFGE Types 3and 5, excluded from the study.</a:t>
            </a:r>
            <a:endParaRPr lang="el-G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7284767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239</Words>
  <Application>Microsoft Macintosh PowerPoint</Application>
  <PresentationFormat>Ευρεία οθόνη</PresentationFormat>
  <Paragraphs>2</Paragraphs>
  <Slides>2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4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Θέμα του Office</vt:lpstr>
      <vt:lpstr>Παρουσίαση του PowerPoint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ΓΙΟΡΜΕΖΗΣ ΝΙΚΟΛΑΟΣ</dc:creator>
  <cp:lastModifiedBy>Σπηλιοπούλου-Σδούγκου Ίριδα</cp:lastModifiedBy>
  <cp:revision>11</cp:revision>
  <dcterms:created xsi:type="dcterms:W3CDTF">2021-04-09T08:00:38Z</dcterms:created>
  <dcterms:modified xsi:type="dcterms:W3CDTF">2021-04-09T09:13:38Z</dcterms:modified>
</cp:coreProperties>
</file>